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6"/>
  </p:notesMasterIdLst>
  <p:sldIdLst>
    <p:sldId id="270" r:id="rId2"/>
    <p:sldId id="301" r:id="rId3"/>
    <p:sldId id="302" r:id="rId4"/>
    <p:sldId id="304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FF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38" autoAdjust="0"/>
    <p:restoredTop sz="96616" autoAdjust="0"/>
  </p:normalViewPr>
  <p:slideViewPr>
    <p:cSldViewPr snapToGrid="0">
      <p:cViewPr varScale="1">
        <p:scale>
          <a:sx n="106" d="100"/>
          <a:sy n="106" d="100"/>
        </p:scale>
        <p:origin x="4008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50AB09-9BD8-4F13-AC67-C4FE45FAA46E}" type="datetimeFigureOut">
              <a:rPr lang="zh-CN" altLang="en-US" smtClean="0"/>
              <a:t>2026/6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663E77-451F-4216-AC2D-2A58D0EA0EF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EF125-941A-43BE-AC8B-A6077E2F1D45}" type="datetimeFigureOut">
              <a:rPr lang="zh-CN" altLang="en-US" smtClean="0"/>
              <a:t>2026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9CC3-C0C6-40C5-BA24-B2C48450D22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EF125-941A-43BE-AC8B-A6077E2F1D45}" type="datetimeFigureOut">
              <a:rPr lang="zh-CN" altLang="en-US" smtClean="0"/>
              <a:t>2026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9CC3-C0C6-40C5-BA24-B2C48450D22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EF125-941A-43BE-AC8B-A6077E2F1D45}" type="datetimeFigureOut">
              <a:rPr lang="zh-CN" altLang="en-US" smtClean="0"/>
              <a:t>2026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9CC3-C0C6-40C5-BA24-B2C48450D22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EF125-941A-43BE-AC8B-A6077E2F1D45}" type="datetimeFigureOut">
              <a:rPr lang="zh-CN" altLang="en-US" smtClean="0"/>
              <a:t>2026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9CC3-C0C6-40C5-BA24-B2C48450D22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EF125-941A-43BE-AC8B-A6077E2F1D45}" type="datetimeFigureOut">
              <a:rPr lang="zh-CN" altLang="en-US" smtClean="0"/>
              <a:t>2026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9CC3-C0C6-40C5-BA24-B2C48450D22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EF125-941A-43BE-AC8B-A6077E2F1D45}" type="datetimeFigureOut">
              <a:rPr lang="zh-CN" altLang="en-US" smtClean="0"/>
              <a:t>2026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9CC3-C0C6-40C5-BA24-B2C48450D22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EF125-941A-43BE-AC8B-A6077E2F1D45}" type="datetimeFigureOut">
              <a:rPr lang="zh-CN" altLang="en-US" smtClean="0"/>
              <a:t>2026/6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9CC3-C0C6-40C5-BA24-B2C48450D22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EF125-941A-43BE-AC8B-A6077E2F1D45}" type="datetimeFigureOut">
              <a:rPr lang="zh-CN" altLang="en-US" smtClean="0"/>
              <a:t>2026/6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9CC3-C0C6-40C5-BA24-B2C48450D22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EF125-941A-43BE-AC8B-A6077E2F1D45}" type="datetimeFigureOut">
              <a:rPr lang="zh-CN" altLang="en-US" smtClean="0"/>
              <a:t>2026/6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9CC3-C0C6-40C5-BA24-B2C48450D22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EF125-941A-43BE-AC8B-A6077E2F1D45}" type="datetimeFigureOut">
              <a:rPr lang="zh-CN" altLang="en-US" smtClean="0"/>
              <a:t>2026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9CC3-C0C6-40C5-BA24-B2C48450D22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EF125-941A-43BE-AC8B-A6077E2F1D45}" type="datetimeFigureOut">
              <a:rPr lang="zh-CN" altLang="en-US" smtClean="0"/>
              <a:t>2026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39CC3-C0C6-40C5-BA24-B2C48450D22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BEF125-941A-43BE-AC8B-A6077E2F1D45}" type="datetimeFigureOut">
              <a:rPr lang="zh-CN" altLang="en-US" smtClean="0"/>
              <a:t>2026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B39CC3-C0C6-40C5-BA24-B2C48450D22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905" indent="-128905" algn="l" defTabSz="514350" rtl="0" eaLnBrk="1" latinLnBrk="0" hangingPunct="1">
        <a:lnSpc>
          <a:spcPct val="90000"/>
        </a:lnSpc>
        <a:spcBef>
          <a:spcPts val="565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60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32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4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1576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4147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6719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9291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1863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6637407"/>
              </p:ext>
            </p:extLst>
          </p:nvPr>
        </p:nvGraphicFramePr>
        <p:xfrm>
          <a:off x="1601002" y="217452"/>
          <a:ext cx="3740152" cy="9333935"/>
        </p:xfrm>
        <a:graphic>
          <a:graphicData uri="http://schemas.openxmlformats.org/drawingml/2006/table">
            <a:tbl>
              <a:tblPr/>
              <a:tblGrid>
                <a:gridCol w="4322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34821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59654">
                  <a:extLst>
                    <a:ext uri="{9D8B030D-6E8A-4147-A177-3AD203B41FA5}">
                      <a16:colId xmlns:a16="http://schemas.microsoft.com/office/drawing/2014/main" val="513466116"/>
                    </a:ext>
                  </a:extLst>
                </a:gridCol>
              </a:tblGrid>
              <a:tr h="6820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umber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ame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</a:t>
                      </a: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olvent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igustrosidic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acid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marogent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8-Epideoxyloganic acid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pecnuezhen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ganet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6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ecoxylogan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icroside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IV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8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enip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</a:t>
                      </a:r>
                      <a:endParaRPr lang="zh-CN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</a:t>
                      </a:r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eacetylasperulosidic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Acid</a:t>
                      </a:r>
                      <a:endParaRPr lang="zh-CN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arracen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1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Oleonuezhen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2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ornu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3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icroside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I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4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icroside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II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5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cevaltrate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6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ganic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acid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7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Harpag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8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L3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9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aederosidic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acid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0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ardeno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1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Valtrate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</a:t>
                      </a:r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hydrine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B4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2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enipo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3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Verbenalin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4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hanzi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5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Bartsio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6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Mitraphylline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7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aederosidic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acid methyl ester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8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6'-O-beta-D-Glucosylgentiopicroside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9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Oleuropeinic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acid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0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aedero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1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esamo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2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8-​O-​</a:t>
                      </a:r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cetylharpag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3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pecneuzhen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4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ecologan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5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Oleuropein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6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Isopteropodin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7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hanzhiside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methyl ester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8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eniposidic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acid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9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atalpol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0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sperulosidic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Acid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1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gnu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2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maroswer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3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jmalicine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4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Melitto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5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Fereto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6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entiopicro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7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ucub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8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Valepotriate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9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a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α,7α,7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α-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epetalactone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0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jugol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1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icroside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III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2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Methyl </a:t>
                      </a:r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eacetylasperulosidat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3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enipin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1-</a:t>
                      </a:r>
                      <a:r>
                        <a:rPr lang="el-G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β-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-</a:t>
                      </a:r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entiobio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4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Hastato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5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icrot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6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sperulo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7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gan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8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Harpago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9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Morroni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60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Barler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61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ehmannioside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C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MSO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62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ecologanos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Water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63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ehmannioside</a:t>
                      </a: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D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Water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64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Monotropein</a:t>
                      </a:r>
                      <a:endParaRPr lang="en-US" altLang="zh-CN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Water</a:t>
                      </a:r>
                    </a:p>
                  </a:txBody>
                  <a:tcPr marL="6439" marR="6439" marT="64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64"/>
                  </a:ext>
                </a:extLst>
              </a:tr>
            </a:tbl>
          </a:graphicData>
        </a:graphic>
      </p:graphicFrame>
      <p:sp>
        <p:nvSpPr>
          <p:cNvPr id="2" name="TextBox 74">
            <a:extLst>
              <a:ext uri="{FF2B5EF4-FFF2-40B4-BE49-F238E27FC236}">
                <a16:creationId xmlns:a16="http://schemas.microsoft.com/office/drawing/2014/main" id="{10D07DF8-60C6-1504-7576-72B23519C8B5}"/>
              </a:ext>
            </a:extLst>
          </p:cNvPr>
          <p:cNvSpPr txBox="1"/>
          <p:nvPr/>
        </p:nvSpPr>
        <p:spPr>
          <a:xfrm>
            <a:off x="1788129" y="11041"/>
            <a:ext cx="3365897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 The list of Iridoid glycosid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64A1FC6-7D64-9CB5-8239-61A3AE4F8BAC}"/>
              </a:ext>
            </a:extLst>
          </p:cNvPr>
          <p:cNvSpPr txBox="1"/>
          <p:nvPr/>
        </p:nvSpPr>
        <p:spPr>
          <a:xfrm>
            <a:off x="973915" y="9591220"/>
            <a:ext cx="522234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compounds were prepared as 10 mM stock solutions in the indicated solvents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0EDEEB02-433F-D5DF-9AC2-0FDCE58803B4}"/>
              </a:ext>
            </a:extLst>
          </p:cNvPr>
          <p:cNvSpPr txBox="1"/>
          <p:nvPr/>
        </p:nvSpPr>
        <p:spPr>
          <a:xfrm>
            <a:off x="1994590" y="98896"/>
            <a:ext cx="286881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 The MS test of the compoun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D44D8B7-7F6F-441C-2773-D52695CCBBD5}"/>
              </a:ext>
            </a:extLst>
          </p:cNvPr>
          <p:cNvSpPr txBox="1"/>
          <p:nvPr/>
        </p:nvSpPr>
        <p:spPr>
          <a:xfrm>
            <a:off x="86225" y="8244254"/>
            <a:ext cx="668554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a wavelength of 254nm, the liquid phase test of the sample is 100%. The molecular weight of 714.7 corresponds to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+N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ositive). The detection result is consistent with the target structure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 descr="图形用户界面&#10;&#10;AI 生成的内容可能不正确。">
            <a:extLst>
              <a:ext uri="{FF2B5EF4-FFF2-40B4-BE49-F238E27FC236}">
                <a16:creationId xmlns:a16="http://schemas.microsoft.com/office/drawing/2014/main" id="{308279EE-0F2F-3436-2755-6B741EC80B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75895"/>
            <a:ext cx="6858000" cy="78221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66643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0DFCF960-9EDA-8F6B-1227-F67CFC3470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6422116"/>
              </p:ext>
            </p:extLst>
          </p:nvPr>
        </p:nvGraphicFramePr>
        <p:xfrm>
          <a:off x="1505844" y="273577"/>
          <a:ext cx="3785352" cy="9592378"/>
        </p:xfrm>
        <a:graphic>
          <a:graphicData uri="http://schemas.openxmlformats.org/drawingml/2006/table">
            <a:tbl>
              <a:tblPr/>
              <a:tblGrid>
                <a:gridCol w="620675">
                  <a:extLst>
                    <a:ext uri="{9D8B030D-6E8A-4147-A177-3AD203B41FA5}">
                      <a16:colId xmlns:a16="http://schemas.microsoft.com/office/drawing/2014/main" val="3974327683"/>
                    </a:ext>
                  </a:extLst>
                </a:gridCol>
                <a:gridCol w="681977">
                  <a:extLst>
                    <a:ext uri="{9D8B030D-6E8A-4147-A177-3AD203B41FA5}">
                      <a16:colId xmlns:a16="http://schemas.microsoft.com/office/drawing/2014/main" val="1618744246"/>
                    </a:ext>
                  </a:extLst>
                </a:gridCol>
                <a:gridCol w="620675">
                  <a:extLst>
                    <a:ext uri="{9D8B030D-6E8A-4147-A177-3AD203B41FA5}">
                      <a16:colId xmlns:a16="http://schemas.microsoft.com/office/drawing/2014/main" val="255395573"/>
                    </a:ext>
                  </a:extLst>
                </a:gridCol>
                <a:gridCol w="620675">
                  <a:extLst>
                    <a:ext uri="{9D8B030D-6E8A-4147-A177-3AD203B41FA5}">
                      <a16:colId xmlns:a16="http://schemas.microsoft.com/office/drawing/2014/main" val="2480585136"/>
                    </a:ext>
                  </a:extLst>
                </a:gridCol>
                <a:gridCol w="620675">
                  <a:extLst>
                    <a:ext uri="{9D8B030D-6E8A-4147-A177-3AD203B41FA5}">
                      <a16:colId xmlns:a16="http://schemas.microsoft.com/office/drawing/2014/main" val="3073857474"/>
                    </a:ext>
                  </a:extLst>
                </a:gridCol>
                <a:gridCol w="620675">
                  <a:extLst>
                    <a:ext uri="{9D8B030D-6E8A-4147-A177-3AD203B41FA5}">
                      <a16:colId xmlns:a16="http://schemas.microsoft.com/office/drawing/2014/main" val="1382486406"/>
                    </a:ext>
                  </a:extLst>
                </a:gridCol>
              </a:tblGrid>
              <a:tr h="25642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rotein IDs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ene names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FQ intensity Ctrl-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FQ intensity Ctrl-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FQ intensity AGN-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FQ intensity AGN-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1611785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7JD0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tp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373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6531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896952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0A0N4SV3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Serbp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658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862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0334475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E9Q2H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agh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4549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334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2190134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0A0U1RNS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sen3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134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692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6264847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9CX5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rmt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060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4552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561479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3U0V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Khsrp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9415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381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2499807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0A3B2WCW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lin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130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534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7213871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0JNU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sp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580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207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9290051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2A54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Rpl1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7144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974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384421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7026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fkfb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4314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139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0708665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2AIL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Ndufaf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173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9351.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7185362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2ALW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najc2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573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154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7067069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3Z4U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Zranb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675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300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6356936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B2RXY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br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203700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329400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7947068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3YTQ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Rps1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418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956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3656267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3YUG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ypla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6090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734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213472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3YY5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ut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452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716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136847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3YYM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Rps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330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4769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2318359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91VM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pa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4942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404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0457412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3Z7P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Bre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6658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235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5807879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545L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cmt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3927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2257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0219310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E9PWW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or1aip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335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827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7517023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6P7V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Smc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933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882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7440103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E9QLQ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de3b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860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769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3917740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F6ZHD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be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8971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7418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100123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F7D5L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Wdr7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4536.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4400.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7530345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F8WHR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dx4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599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3300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809410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3X9M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ap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4095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804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3959852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5E86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Sf3b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8319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6556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80792948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7BX8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rat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930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7610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4979053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9CY2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smd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257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123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0619804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3UKJ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hx1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1838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9788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8551564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O3532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Srsf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7124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8757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5122438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7TMG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bas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2605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7118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0077038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0049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prt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4233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4224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2940002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1103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Sub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284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7478.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0710597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2777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dia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951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363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4909012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3UIH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smc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578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621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3814680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3UHW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sd17b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010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304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7508734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5637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cyp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7802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8353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8387831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3TD5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ical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231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450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954116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3UGM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Mfn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752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906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3520166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4FK1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Nono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6796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450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603008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3U31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Rbm3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2365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7931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2976319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80X3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Slc9a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7897.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158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21335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3U3G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Rnf12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490.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9715.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5816145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6085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Serpinb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2296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9045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6545562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3UEB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uf6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900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7537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1534150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3UIB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hrs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9509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1833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7659397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6473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art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270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492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9522240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3USZ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Nop5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8681.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366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1092311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3UZ1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uc7l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0508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5323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9286011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4L0E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Krt7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456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116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4509427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544I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Ndrg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368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332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5115279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5SUF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uc7l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0126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6597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3144826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921L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tn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808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844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6551027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6074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Khdrbs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786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964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8704858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6242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st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6192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5760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3132630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8BHC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cakd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909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777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8315818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8BI7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dkn2aip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151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097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7791019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922B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Macrod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626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194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0751772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99LS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sp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207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658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0549153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99P3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Nudt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511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62316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9457254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9CPZ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mc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681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546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77217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9CQ6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Mtap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2206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2557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362898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9GX6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Mrpl2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758.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7859.2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5045807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9CWG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Ndufaf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464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9518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176765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9D0T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Nhp2l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68067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1525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6436364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9D8S9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Bola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40443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4160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3046688"/>
                  </a:ext>
                </a:extLst>
              </a:tr>
              <a:tr h="87354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Q9Z1T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p3b1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280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50204</a:t>
                      </a:r>
                    </a:p>
                  </a:txBody>
                  <a:tcPr marL="4598" marR="4598" marT="459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279628"/>
                  </a:ext>
                </a:extLst>
              </a:tr>
            </a:tbl>
          </a:graphicData>
        </a:graphic>
      </p:graphicFrame>
      <p:sp>
        <p:nvSpPr>
          <p:cNvPr id="5" name="TextBox 74">
            <a:extLst>
              <a:ext uri="{FF2B5EF4-FFF2-40B4-BE49-F238E27FC236}">
                <a16:creationId xmlns:a16="http://schemas.microsoft.com/office/drawing/2014/main" id="{65445160-ECA2-4D38-10DA-2FDDC7F439E5}"/>
              </a:ext>
            </a:extLst>
          </p:cNvPr>
          <p:cNvSpPr txBox="1"/>
          <p:nvPr/>
        </p:nvSpPr>
        <p:spPr>
          <a:xfrm>
            <a:off x="-246777" y="40045"/>
            <a:ext cx="7351554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3 LC-MS/MS profile of proteins identified by biotinylated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nuside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ull-down assay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85952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CD5DB68C-F0F5-3D64-0536-7E6BA6ED07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6536418"/>
              </p:ext>
            </p:extLst>
          </p:nvPr>
        </p:nvGraphicFramePr>
        <p:xfrm>
          <a:off x="301752" y="554213"/>
          <a:ext cx="6167355" cy="8358342"/>
        </p:xfrm>
        <a:graphic>
          <a:graphicData uri="http://schemas.openxmlformats.org/drawingml/2006/table">
            <a:tbl>
              <a:tblPr firstRow="1" firstCol="1" bandRow="1"/>
              <a:tblGrid>
                <a:gridCol w="1865376">
                  <a:extLst>
                    <a:ext uri="{9D8B030D-6E8A-4147-A177-3AD203B41FA5}">
                      <a16:colId xmlns:a16="http://schemas.microsoft.com/office/drawing/2014/main" val="769176223"/>
                    </a:ext>
                  </a:extLst>
                </a:gridCol>
                <a:gridCol w="1892808">
                  <a:extLst>
                    <a:ext uri="{9D8B030D-6E8A-4147-A177-3AD203B41FA5}">
                      <a16:colId xmlns:a16="http://schemas.microsoft.com/office/drawing/2014/main" val="3158878805"/>
                    </a:ext>
                  </a:extLst>
                </a:gridCol>
                <a:gridCol w="2409171">
                  <a:extLst>
                    <a:ext uri="{9D8B030D-6E8A-4147-A177-3AD203B41FA5}">
                      <a16:colId xmlns:a16="http://schemas.microsoft.com/office/drawing/2014/main" val="3002996485"/>
                    </a:ext>
                  </a:extLst>
                </a:gridCol>
              </a:tblGrid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ene name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orward primer</a:t>
                      </a:r>
                      <a:endParaRPr lang="zh-CN" sz="9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everse primer</a:t>
                      </a:r>
                      <a:endParaRPr lang="zh-CN" sz="9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9071959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ouse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zh-CN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  <a:endParaRPr lang="zh-CN" sz="900" kern="10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zh-CN" sz="9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0672706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U36</a:t>
                      </a:r>
                      <a:r>
                        <a:rPr lang="en-US" altLang="zh-CN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4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aaactgctgcctcacatcc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ctggcacagtgacctcacac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9564332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parɣ2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atgctgttatgggtgaa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gtaatttcttgtgaagtg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7027005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abp4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gcgtgacttccacaagagttt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cctcttcctttggctcat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8773578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gc-1</a:t>
                      </a:r>
                      <a:r>
                        <a:rPr lang="el-GR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α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accacacccacaggatcag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cttcgctttattgctccatg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1588219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gc-1</a:t>
                      </a:r>
                      <a:r>
                        <a:rPr lang="el-GR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β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cgagctcttccagattgac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gtaagcgcagccaagag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5223601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fam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gtctatcagtcttgtctg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tgtatgctttccactcag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7017871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tgl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acgccactcacatctac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ataatgttggcacctgc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515094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sl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gctacacaaaggctgc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ctcgttgcgtttgtagtg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1185718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gll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tccacagaatgttccctacc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tcataacggccacagtgtt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3936444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adm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ctggagacattgccaatc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gcgtccctcatcagcttc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2790534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pt1b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ggcacctctgggagttt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tggctcacccacacagt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3490294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hchd3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cggacgagaacgagaaca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cgctgagacttagagccag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7655538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dhb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atttgccatttaccgatggg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catccaacaccataggtc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431724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dh3b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ggagaggtctcggaacatc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ccttgaacacttccttg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3199422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gdh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tttcttcaaacgtggggttc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catgattccaggggtctcaa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9501536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ox7a1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aaaaccgtgtggcagag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gcgtcatggtcagtct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5427468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137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gtcagcctggtactttct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tgtgtgcaggctatttc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6000689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bx1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gcaggcagacgaatgtt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aaagcataccggtagcgc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7664733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mem26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taatgtcagaaccaacc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caactggactgccagatc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8785380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idea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gggtagtaagtatgtccc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gcataggacataaacctc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4419371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sz="900" i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io2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atgctcccaattccagtg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gaaccaaagttgaccacc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5671111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i="0" kern="100" dirty="0" err="1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atm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acctggtcttgtgctctc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ggatgactggtgttggag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9202266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i="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erca2b</a:t>
                      </a:r>
                      <a:endParaRPr lang="zh-CN" sz="900" i="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ctttgccgctcattttcc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gctgcacacactctttac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4048136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yr2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tggctttaaggcacagc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gagcccgaatcatccag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996679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dufb6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aagaacatggtctttaag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tggtttagtagccatatg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6006240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dufaf5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aaggaggaggttggaagt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cacagtctccttatccaa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0431376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dufaf6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ctgctgaggaaacgaga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cttgacagccttccaga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6243851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dufb1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ggctgaagcagtcaaga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ctcagttccctttgaaat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5609643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Uqcrc1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acctgcacggtgggagt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tctaaggcattgccaggc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2645246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yc1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ggctgaggaggtggaggt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caccatgcctagctcga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1643767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 err="1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Uqcrh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cccaaagaggaagaagag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tgtgggccacacagtggtc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1278291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 err="1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Uqcrq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tgggccgcgagtttggga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tacaaacggcggcgcc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2798405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dufa4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agccaagaagcatccc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ctgtcccagctgacatct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6331532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ox6c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tgagttccggtgcgctg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cacgccaaacttataggc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8408326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 err="1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poo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atcgatgagctttcactc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ggagtatatttcctgac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9081614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 err="1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pool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tggtgcaagagcatttat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acctggaaccttttcttg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261836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t-Cox2</a:t>
                      </a:r>
                    </a:p>
                    <a:p>
                      <a:pPr algn="ctr"/>
                      <a:r>
                        <a:rPr lang="en-US" altLang="zh-CN" sz="9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the mitochondrial reference gene)</a:t>
                      </a:r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catgatcacacactaata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acagctggtagaatagtt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6578118"/>
                  </a:ext>
                </a:extLst>
              </a:tr>
              <a:tr h="20190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β-Actin</a:t>
                      </a:r>
                    </a:p>
                    <a:p>
                      <a:pPr algn="ctr"/>
                      <a:r>
                        <a:rPr lang="en-US" altLang="zh-CN" sz="9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the nuclear reference gene)</a:t>
                      </a:r>
                      <a:endParaRPr lang="zh-CN" altLang="zh-CN" sz="9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zh-CN" sz="9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1899" marR="61899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tggcattgttaccaact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aacatgatctgggtcat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2237910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B315091B-B9A5-B858-1E5A-69BED67D63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3601" y="89879"/>
            <a:ext cx="538170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</a:t>
            </a:r>
            <a:r>
              <a:rPr lang="en-US" altLang="zh-CN" sz="12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4</a:t>
            </a:r>
            <a:r>
              <a:rPr kumimoji="0" lang="en-US" altLang="zh-CN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equences of qPCR primers used in this study</a:t>
            </a:r>
            <a:endParaRPr kumimoji="0" lang="en-US" altLang="zh-CN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6195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56</TotalTime>
  <Words>901</Words>
  <Application>Microsoft Office PowerPoint</Application>
  <PresentationFormat>A4 纸张(210x297 毫米)</PresentationFormat>
  <Paragraphs>749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清雯 赵</dc:creator>
  <cp:lastModifiedBy>清雯 赵</cp:lastModifiedBy>
  <cp:revision>455</cp:revision>
  <cp:lastPrinted>2026-02-11T10:35:00Z</cp:lastPrinted>
  <dcterms:created xsi:type="dcterms:W3CDTF">2024-03-31T11:26:00Z</dcterms:created>
  <dcterms:modified xsi:type="dcterms:W3CDTF">2026-06-04T08:06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5007132D98D4D5D951983A3E07956CC_12</vt:lpwstr>
  </property>
  <property fmtid="{D5CDD505-2E9C-101B-9397-08002B2CF9AE}" pid="3" name="KSOProductBuildVer">
    <vt:lpwstr>2052-12.1.0.21171</vt:lpwstr>
  </property>
</Properties>
</file>